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9"/>
  </p:notesMasterIdLst>
  <p:sldIdLst>
    <p:sldId id="276" r:id="rId2"/>
    <p:sldId id="272" r:id="rId3"/>
    <p:sldId id="271" r:id="rId4"/>
    <p:sldId id="268" r:id="rId5"/>
    <p:sldId id="270" r:id="rId6"/>
    <p:sldId id="278" r:id="rId7"/>
    <p:sldId id="277" r:id="rId8"/>
  </p:sldIdLst>
  <p:sldSz cx="7559675" cy="10691813"/>
  <p:notesSz cx="6794500" cy="9931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DE8EB23-ACD7-3238-55B7-5C4DC2925CF8}" name="Mark Daniel Bunting" initials="MB" userId="S::A1120531@adelaide.edu.au::377c0b4c-6cb3-47f5-bd42-8239564e1fa9" providerId="AD"/>
  <p188:author id="{F52D802F-DF1F-6102-42CF-F883FA557EEE}" name="Gelshan Godahewa" initials="GG" userId="ASfQ86OoQOrdMolqZq3o77kzJ2H+EnvdFXO4Y1GlA7U=" providerId="None"/>
  <p188:author id="{49685F48-516C-F355-FEC1-AB82C5B589AA}" name="Louise Robertson" initials="LR" userId="S::Louise.Robertson@sahmri.com::eeb8a9e8-539c-4851-8623-d856f38c2477" providerId="AD"/>
  <p188:author id="{3A0FAB7A-8A28-DEC2-351D-20805C416C20}" name="Gelshan Godahewa" initials="GG" userId="S::a1226938@adelaide.edu.au::c7a65f2e-2aac-4d17-9478-8737ea42f5ff" providerId="AD"/>
  <p188:author id="{06D31D9A-64A0-979D-FBC3-FDA2F8D3EB60}" name="Louise Robertson" initials="LR" userId="S::louise.robertson@sahmri.com::eeb8a9e8-539c-4851-8623-d856f38c2477" providerId="AD"/>
  <p188:author id="{0055C0AA-854E-270F-C8BA-5FF5D6D0E889}" name="Mark Daniel Bunting" initials="MDB" userId="S::a1120531@adelaide.edu.au::377c0b4c-6cb3-47f5-bd42-8239564e1fa9" providerId="AD"/>
  <p188:author id="{3A74C0BF-C661-F5BF-FF55-8DDC756580AA}" name="Paul Thomas" initials="PT" userId="S::a1019574@adelaide.edu.au::fa727589-0e5b-4e21-8e2e-48bd461c0c4c" providerId="AD"/>
  <p188:author id="{1F8B40C0-78CA-F13A-CA47-044FDBF40975}" name="Luke Gierus" initials="LG" userId="807a138f89ae98ee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3C96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5714" autoAdjust="0"/>
    <p:restoredTop sz="95946"/>
  </p:normalViewPr>
  <p:slideViewPr>
    <p:cSldViewPr snapToGrid="0" snapToObjects="1">
      <p:cViewPr varScale="1">
        <p:scale>
          <a:sx n="69" d="100"/>
          <a:sy n="69" d="100"/>
        </p:scale>
        <p:origin x="264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2452A0-0F45-4F34-B632-63190163D163}" type="datetimeFigureOut">
              <a:t>12/5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12975" y="1241425"/>
            <a:ext cx="2368550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9486"/>
            <a:ext cx="5435600" cy="391048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3107"/>
            <a:ext cx="2944283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8645" y="9433107"/>
            <a:ext cx="2944283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0D4F84-AB90-48E0-9B81-33DC036E4C5A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2997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(A) </a:t>
            </a:r>
            <a:r>
              <a:rPr lang="en-US" dirty="0"/>
              <a:t>X chromosome indel analysis</a:t>
            </a:r>
          </a:p>
          <a:p>
            <a:r>
              <a:rPr lang="en-US" dirty="0">
                <a:cs typeface="Calibri"/>
              </a:rPr>
              <a:t>(B) </a:t>
            </a:r>
            <a:r>
              <a:rPr lang="en-US" dirty="0"/>
              <a:t>X/Y dosage qPCR</a:t>
            </a:r>
            <a:endParaRPr lang="en-US" dirty="0">
              <a:cs typeface="Calibri"/>
            </a:endParaRPr>
          </a:p>
          <a:p>
            <a:r>
              <a:rPr lang="en-US" dirty="0">
                <a:cs typeface="Calibri"/>
              </a:rPr>
              <a:t>(C) F1 females with indel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D0D4F84-AB90-48E0-9B81-33DC036E4C5A}" type="slidenum">
              <a:rPr lang="en-US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77921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(A) </a:t>
            </a:r>
            <a:r>
              <a:rPr lang="en-US" dirty="0"/>
              <a:t>X chromosome indel analysis</a:t>
            </a:r>
          </a:p>
          <a:p>
            <a:r>
              <a:rPr lang="en-US" dirty="0">
                <a:cs typeface="Calibri"/>
              </a:rPr>
              <a:t>(B) </a:t>
            </a:r>
            <a:r>
              <a:rPr lang="en-US" dirty="0"/>
              <a:t>X/Y dosage qPCR</a:t>
            </a:r>
            <a:endParaRPr lang="en-US" dirty="0">
              <a:cs typeface="Calibri"/>
            </a:endParaRPr>
          </a:p>
          <a:p>
            <a:r>
              <a:rPr lang="en-US" dirty="0">
                <a:cs typeface="Calibri"/>
              </a:rPr>
              <a:t>(C) F1 females with indel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D0D4F84-AB90-48E0-9B81-33DC036E4C5A}" type="slidenum">
              <a:rPr lang="en-US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60285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(D) Cas9 Carryover effect – F1 male</a:t>
            </a:r>
          </a:p>
          <a:p>
            <a:r>
              <a:rPr lang="en-US" dirty="0">
                <a:cs typeface="Calibri"/>
              </a:rPr>
              <a:t>(E) Blastocyst experiment</a:t>
            </a:r>
          </a:p>
          <a:p>
            <a:r>
              <a:rPr lang="en-US" dirty="0">
                <a:cs typeface="Calibri"/>
              </a:rPr>
              <a:t>(F) Y Chr PCR on blastocyst samples (1-44 experimental samples, a-d WT samples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D0D4F84-AB90-48E0-9B81-33DC036E4C5A}" type="slidenum">
              <a:rPr lang="en-US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45271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(A) </a:t>
            </a:r>
            <a:r>
              <a:rPr lang="en-US" dirty="0"/>
              <a:t>X chromosome indel analysis</a:t>
            </a:r>
          </a:p>
          <a:p>
            <a:r>
              <a:rPr lang="en-US" dirty="0">
                <a:cs typeface="Calibri"/>
              </a:rPr>
              <a:t>(B) </a:t>
            </a:r>
            <a:r>
              <a:rPr lang="en-US" dirty="0"/>
              <a:t>X/Y dosage qPCR</a:t>
            </a:r>
            <a:endParaRPr lang="en-US" dirty="0">
              <a:cs typeface="Calibri"/>
            </a:endParaRPr>
          </a:p>
          <a:p>
            <a:r>
              <a:rPr lang="en-US" dirty="0">
                <a:cs typeface="Calibri"/>
              </a:rPr>
              <a:t>(C) F1 females with indel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D0D4F84-AB90-48E0-9B81-33DC036E4C5A}" type="slidenum">
              <a:rPr lang="en-US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4726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6BCAA-2CF3-4C4E-8FFF-EE37875B1DC7}" type="datetimeFigureOut">
              <a:rPr lang="en-AU" smtClean="0"/>
              <a:t>5/12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55064-DC17-8F4D-84F0-2738D7E15D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951377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6BCAA-2CF3-4C4E-8FFF-EE37875B1DC7}" type="datetimeFigureOut">
              <a:rPr lang="en-AU" smtClean="0"/>
              <a:t>5/12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55064-DC17-8F4D-84F0-2738D7E15D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66411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6BCAA-2CF3-4C4E-8FFF-EE37875B1DC7}" type="datetimeFigureOut">
              <a:rPr lang="en-AU" smtClean="0"/>
              <a:t>5/12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55064-DC17-8F4D-84F0-2738D7E15D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669495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6BCAA-2CF3-4C4E-8FFF-EE37875B1DC7}" type="datetimeFigureOut">
              <a:rPr lang="en-AU" smtClean="0"/>
              <a:t>5/12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55064-DC17-8F4D-84F0-2738D7E15D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28692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6BCAA-2CF3-4C4E-8FFF-EE37875B1DC7}" type="datetimeFigureOut">
              <a:rPr lang="en-AU" smtClean="0"/>
              <a:t>5/12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55064-DC17-8F4D-84F0-2738D7E15D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89708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6BCAA-2CF3-4C4E-8FFF-EE37875B1DC7}" type="datetimeFigureOut">
              <a:rPr lang="en-AU" smtClean="0"/>
              <a:t>5/12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55064-DC17-8F4D-84F0-2738D7E15D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77472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6BCAA-2CF3-4C4E-8FFF-EE37875B1DC7}" type="datetimeFigureOut">
              <a:rPr lang="en-AU" smtClean="0"/>
              <a:t>5/12/2023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55064-DC17-8F4D-84F0-2738D7E15D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760007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6BCAA-2CF3-4C4E-8FFF-EE37875B1DC7}" type="datetimeFigureOut">
              <a:rPr lang="en-AU" smtClean="0"/>
              <a:t>5/12/2023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55064-DC17-8F4D-84F0-2738D7E15D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933195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6BCAA-2CF3-4C4E-8FFF-EE37875B1DC7}" type="datetimeFigureOut">
              <a:rPr lang="en-AU" smtClean="0"/>
              <a:t>5/12/2023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55064-DC17-8F4D-84F0-2738D7E15D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317680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6BCAA-2CF3-4C4E-8FFF-EE37875B1DC7}" type="datetimeFigureOut">
              <a:rPr lang="en-AU" smtClean="0"/>
              <a:t>5/12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55064-DC17-8F4D-84F0-2738D7E15D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247330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6BCAA-2CF3-4C4E-8FFF-EE37875B1DC7}" type="datetimeFigureOut">
              <a:rPr lang="en-AU" smtClean="0"/>
              <a:t>5/12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55064-DC17-8F4D-84F0-2738D7E15D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440989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36BCAA-2CF3-4C4E-8FFF-EE37875B1DC7}" type="datetimeFigureOut">
              <a:rPr lang="en-AU" smtClean="0"/>
              <a:t>5/12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355064-DC17-8F4D-84F0-2738D7E15D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70160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12" Type="http://schemas.openxmlformats.org/officeDocument/2006/relationships/image" Target="../media/image1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11" Type="http://schemas.openxmlformats.org/officeDocument/2006/relationships/image" Target="../media/image13.png"/><Relationship Id="rId5" Type="http://schemas.openxmlformats.org/officeDocument/2006/relationships/image" Target="../media/image7.png"/><Relationship Id="rId10" Type="http://schemas.openxmlformats.org/officeDocument/2006/relationships/image" Target="../media/image12.png"/><Relationship Id="rId4" Type="http://schemas.openxmlformats.org/officeDocument/2006/relationships/image" Target="../media/image6.png"/><Relationship Id="rId9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13" Type="http://schemas.openxmlformats.org/officeDocument/2006/relationships/image" Target="../media/image27.png"/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12" Type="http://schemas.openxmlformats.org/officeDocument/2006/relationships/image" Target="../media/image26.pn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3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0.png"/><Relationship Id="rId11" Type="http://schemas.openxmlformats.org/officeDocument/2006/relationships/image" Target="../media/image25.png"/><Relationship Id="rId5" Type="http://schemas.openxmlformats.org/officeDocument/2006/relationships/image" Target="../media/image19.png"/><Relationship Id="rId15" Type="http://schemas.openxmlformats.org/officeDocument/2006/relationships/image" Target="../media/image29.png"/><Relationship Id="rId10" Type="http://schemas.openxmlformats.org/officeDocument/2006/relationships/image" Target="../media/image24.png"/><Relationship Id="rId4" Type="http://schemas.openxmlformats.org/officeDocument/2006/relationships/image" Target="../media/image18.png"/><Relationship Id="rId9" Type="http://schemas.openxmlformats.org/officeDocument/2006/relationships/image" Target="../media/image23.png"/><Relationship Id="rId14" Type="http://schemas.openxmlformats.org/officeDocument/2006/relationships/image" Target="../media/image28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86C70CE-F974-1E12-168A-4F70BBC50760}"/>
              </a:ext>
            </a:extLst>
          </p:cNvPr>
          <p:cNvSpPr txBox="1"/>
          <p:nvPr/>
        </p:nvSpPr>
        <p:spPr>
          <a:xfrm>
            <a:off x="180000" y="72000"/>
            <a:ext cx="7379675" cy="424728"/>
          </a:xfrm>
          <a:prstGeom prst="rect">
            <a:avLst/>
          </a:prstGeom>
          <a:noFill/>
        </p:spPr>
        <p:txBody>
          <a:bodyPr wrap="square" lIns="146300" tIns="73150" rIns="146300" bIns="73150" rtlCol="0" anchor="t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 Figure 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62F36D2-1ADE-3D1A-3BDC-99CACE72A95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531"/>
          <a:stretch/>
        </p:blipFill>
        <p:spPr>
          <a:xfrm>
            <a:off x="1495343" y="632552"/>
            <a:ext cx="5803821" cy="546123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8206461-EAB9-3C12-67F3-C255E505B04D}"/>
              </a:ext>
            </a:extLst>
          </p:cNvPr>
          <p:cNvSpPr txBox="1"/>
          <p:nvPr/>
        </p:nvSpPr>
        <p:spPr>
          <a:xfrm>
            <a:off x="856616" y="1018020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X-C site 1</a:t>
            </a:r>
            <a:endParaRPr lang="en-AU" sz="1000" baseline="30000" dirty="0"/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85708215-873C-4D80-33AB-8D37EBB9F12A}"/>
              </a:ext>
            </a:extLst>
          </p:cNvPr>
          <p:cNvCxnSpPr>
            <a:cxnSpLocks/>
          </p:cNvCxnSpPr>
          <p:nvPr/>
        </p:nvCxnSpPr>
        <p:spPr>
          <a:xfrm>
            <a:off x="1445340" y="1010871"/>
            <a:ext cx="0" cy="252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17F6597B-5B21-E1CC-A0F8-74DC130CD0A3}"/>
              </a:ext>
            </a:extLst>
          </p:cNvPr>
          <p:cNvSpPr txBox="1"/>
          <p:nvPr/>
        </p:nvSpPr>
        <p:spPr>
          <a:xfrm>
            <a:off x="136558" y="1018020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X-</a:t>
            </a:r>
            <a:r>
              <a:rPr lang="en-AU" sz="1000" dirty="0" err="1"/>
              <a:t>C</a:t>
            </a:r>
            <a:r>
              <a:rPr lang="en-AU" sz="1000" baseline="30000" dirty="0" err="1"/>
              <a:t>Tg</a:t>
            </a:r>
            <a:endParaRPr lang="en-AU" sz="1000" baseline="300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364E48F-FA38-AAE6-4EAA-5A061BF0CDE7}"/>
              </a:ext>
            </a:extLst>
          </p:cNvPr>
          <p:cNvSpPr txBox="1"/>
          <p:nvPr/>
        </p:nvSpPr>
        <p:spPr>
          <a:xfrm>
            <a:off x="136558" y="1420707"/>
            <a:ext cx="7617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X-</a:t>
            </a:r>
            <a:r>
              <a:rPr lang="en-AU" sz="1000" dirty="0" err="1"/>
              <a:t>B</a:t>
            </a:r>
            <a:r>
              <a:rPr lang="en-AU" sz="1000" baseline="30000" dirty="0" err="1"/>
              <a:t>Tg</a:t>
            </a:r>
            <a:r>
              <a:rPr lang="en-AU" sz="1000" dirty="0"/>
              <a:t>; X-</a:t>
            </a:r>
            <a:r>
              <a:rPr lang="en-AU" sz="1000" dirty="0" err="1"/>
              <a:t>C</a:t>
            </a:r>
            <a:r>
              <a:rPr lang="en-AU" sz="1000" baseline="30000" dirty="0" err="1"/>
              <a:t>Tg</a:t>
            </a:r>
            <a:endParaRPr lang="en-AU" sz="1000" baseline="300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FF50E17-B53D-7732-BDB8-F11DD7152866}"/>
              </a:ext>
            </a:extLst>
          </p:cNvPr>
          <p:cNvSpPr txBox="1"/>
          <p:nvPr/>
        </p:nvSpPr>
        <p:spPr>
          <a:xfrm>
            <a:off x="856616" y="1420707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X-C site 1</a:t>
            </a:r>
            <a:endParaRPr lang="en-AU" sz="1000" baseline="300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38198C4-36E6-4312-D789-E7DC9985E82A}"/>
              </a:ext>
            </a:extLst>
          </p:cNvPr>
          <p:cNvSpPr txBox="1"/>
          <p:nvPr/>
        </p:nvSpPr>
        <p:spPr>
          <a:xfrm>
            <a:off x="856616" y="1780547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X-C site 1</a:t>
            </a:r>
            <a:endParaRPr lang="en-AU" sz="1000" baseline="300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56D4CB4-FA28-F084-F66D-FF93A73A2FAA}"/>
              </a:ext>
            </a:extLst>
          </p:cNvPr>
          <p:cNvSpPr txBox="1"/>
          <p:nvPr/>
        </p:nvSpPr>
        <p:spPr>
          <a:xfrm>
            <a:off x="846998" y="2701079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X-D site 1</a:t>
            </a:r>
            <a:endParaRPr lang="en-AU" sz="1000" baseline="300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3DCA4F2-571C-1BFC-E1AC-AADC709F8A91}"/>
              </a:ext>
            </a:extLst>
          </p:cNvPr>
          <p:cNvSpPr txBox="1"/>
          <p:nvPr/>
        </p:nvSpPr>
        <p:spPr>
          <a:xfrm>
            <a:off x="846998" y="4218325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X-D site 1</a:t>
            </a:r>
            <a:endParaRPr lang="en-AU" sz="1000" baseline="300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2E673E3-7297-3702-0935-15CCFC4ABE72}"/>
              </a:ext>
            </a:extLst>
          </p:cNvPr>
          <p:cNvSpPr txBox="1"/>
          <p:nvPr/>
        </p:nvSpPr>
        <p:spPr>
          <a:xfrm>
            <a:off x="846998" y="5431929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X-D site 1</a:t>
            </a:r>
            <a:endParaRPr lang="en-AU" sz="1000" baseline="300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2DFE7C3-6EFA-E4AF-79D5-67287458F6F4}"/>
              </a:ext>
            </a:extLst>
          </p:cNvPr>
          <p:cNvSpPr txBox="1"/>
          <p:nvPr/>
        </p:nvSpPr>
        <p:spPr>
          <a:xfrm>
            <a:off x="136558" y="1780547"/>
            <a:ext cx="7697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X-</a:t>
            </a:r>
            <a:r>
              <a:rPr lang="en-AU" sz="1000" dirty="0" err="1"/>
              <a:t>C</a:t>
            </a:r>
            <a:r>
              <a:rPr lang="en-AU" sz="1000" baseline="30000" dirty="0" err="1"/>
              <a:t>Tg</a:t>
            </a:r>
            <a:r>
              <a:rPr lang="en-AU" sz="1000" dirty="0"/>
              <a:t>; X-</a:t>
            </a:r>
            <a:r>
              <a:rPr lang="en-AU" sz="1000" dirty="0" err="1"/>
              <a:t>D</a:t>
            </a:r>
            <a:r>
              <a:rPr lang="en-AU" sz="1000" baseline="30000" dirty="0" err="1"/>
              <a:t>Tg</a:t>
            </a:r>
            <a:endParaRPr lang="en-AU" sz="1000" baseline="300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469F511-490C-EF93-C12B-CB7B32DFA3CF}"/>
              </a:ext>
            </a:extLst>
          </p:cNvPr>
          <p:cNvSpPr txBox="1"/>
          <p:nvPr/>
        </p:nvSpPr>
        <p:spPr>
          <a:xfrm>
            <a:off x="136558" y="2701079"/>
            <a:ext cx="4507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X-</a:t>
            </a:r>
            <a:r>
              <a:rPr lang="en-AU" sz="1000" dirty="0" err="1"/>
              <a:t>D</a:t>
            </a:r>
            <a:r>
              <a:rPr lang="en-AU" sz="1000" baseline="30000" dirty="0" err="1"/>
              <a:t>Tg</a:t>
            </a:r>
            <a:endParaRPr lang="en-AU" sz="1000" baseline="300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1C8FB21-DB47-F047-ABC4-4288A0D09BFD}"/>
              </a:ext>
            </a:extLst>
          </p:cNvPr>
          <p:cNvSpPr txBox="1"/>
          <p:nvPr/>
        </p:nvSpPr>
        <p:spPr>
          <a:xfrm>
            <a:off x="136558" y="4218325"/>
            <a:ext cx="7713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X-</a:t>
            </a:r>
            <a:r>
              <a:rPr lang="en-AU" sz="1000" dirty="0" err="1"/>
              <a:t>B</a:t>
            </a:r>
            <a:r>
              <a:rPr lang="en-AU" sz="1000" baseline="30000" dirty="0" err="1"/>
              <a:t>Tg</a:t>
            </a:r>
            <a:r>
              <a:rPr lang="en-AU" sz="1000" dirty="0"/>
              <a:t>; X-</a:t>
            </a:r>
            <a:r>
              <a:rPr lang="en-AU" sz="1000" dirty="0" err="1"/>
              <a:t>D</a:t>
            </a:r>
            <a:r>
              <a:rPr lang="en-AU" sz="1000" baseline="30000" dirty="0" err="1"/>
              <a:t>Tg</a:t>
            </a:r>
            <a:endParaRPr lang="en-AU" sz="1000" baseline="300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3D44023-9474-5271-DE3F-24EA99BED21D}"/>
              </a:ext>
            </a:extLst>
          </p:cNvPr>
          <p:cNvSpPr txBox="1"/>
          <p:nvPr/>
        </p:nvSpPr>
        <p:spPr>
          <a:xfrm>
            <a:off x="136558" y="5431929"/>
            <a:ext cx="7713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X-</a:t>
            </a:r>
            <a:r>
              <a:rPr lang="en-AU" sz="1000" dirty="0" err="1"/>
              <a:t>C</a:t>
            </a:r>
            <a:r>
              <a:rPr lang="en-AU" sz="1000" baseline="30000" dirty="0" err="1"/>
              <a:t>Tg</a:t>
            </a:r>
            <a:r>
              <a:rPr lang="en-AU" sz="1000" dirty="0"/>
              <a:t>; X-</a:t>
            </a:r>
            <a:r>
              <a:rPr lang="en-AU" sz="1000" dirty="0" err="1"/>
              <a:t>D</a:t>
            </a:r>
            <a:r>
              <a:rPr lang="en-AU" sz="1000" baseline="30000" dirty="0" err="1"/>
              <a:t>Tg</a:t>
            </a:r>
            <a:endParaRPr lang="en-AU" sz="1000" baseline="300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E7B7BCB-3099-1A2D-A843-303E89D6A306}"/>
              </a:ext>
            </a:extLst>
          </p:cNvPr>
          <p:cNvSpPr txBox="1"/>
          <p:nvPr/>
        </p:nvSpPr>
        <p:spPr>
          <a:xfrm>
            <a:off x="136558" y="770863"/>
            <a:ext cx="577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b="1" dirty="0"/>
              <a:t>Sample</a:t>
            </a:r>
            <a:endParaRPr lang="en-AU" sz="1000" b="1" baseline="300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F8895DA-EAD0-4B9B-AE5B-3C4F26B72245}"/>
              </a:ext>
            </a:extLst>
          </p:cNvPr>
          <p:cNvSpPr txBox="1"/>
          <p:nvPr/>
        </p:nvSpPr>
        <p:spPr>
          <a:xfrm>
            <a:off x="856616" y="765203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b="1" dirty="0"/>
              <a:t>Target</a:t>
            </a:r>
            <a:endParaRPr lang="en-AU" sz="1000" b="1" baseline="30000" dirty="0"/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DE4D74C0-C1EA-E78D-91B2-B7D822238318}"/>
              </a:ext>
            </a:extLst>
          </p:cNvPr>
          <p:cNvCxnSpPr>
            <a:cxnSpLocks/>
          </p:cNvCxnSpPr>
          <p:nvPr/>
        </p:nvCxnSpPr>
        <p:spPr>
          <a:xfrm>
            <a:off x="1445340" y="1414019"/>
            <a:ext cx="0" cy="252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B81C4C02-D687-E17D-E5EA-0814F1F70502}"/>
              </a:ext>
            </a:extLst>
          </p:cNvPr>
          <p:cNvCxnSpPr>
            <a:cxnSpLocks/>
          </p:cNvCxnSpPr>
          <p:nvPr/>
        </p:nvCxnSpPr>
        <p:spPr>
          <a:xfrm>
            <a:off x="1445340" y="1778536"/>
            <a:ext cx="0" cy="252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867271FE-CC5D-EEE1-444E-FD4406289A13}"/>
              </a:ext>
            </a:extLst>
          </p:cNvPr>
          <p:cNvCxnSpPr>
            <a:cxnSpLocks/>
          </p:cNvCxnSpPr>
          <p:nvPr/>
        </p:nvCxnSpPr>
        <p:spPr>
          <a:xfrm>
            <a:off x="1445340" y="2148124"/>
            <a:ext cx="0" cy="1463337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8718370A-E97E-9B72-3507-FE53E3533733}"/>
              </a:ext>
            </a:extLst>
          </p:cNvPr>
          <p:cNvCxnSpPr>
            <a:cxnSpLocks/>
          </p:cNvCxnSpPr>
          <p:nvPr/>
        </p:nvCxnSpPr>
        <p:spPr>
          <a:xfrm>
            <a:off x="1445340" y="3735041"/>
            <a:ext cx="0" cy="128157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EE8F6284-AE43-9BF5-09EF-BA1024CD32ED}"/>
              </a:ext>
            </a:extLst>
          </p:cNvPr>
          <p:cNvCxnSpPr>
            <a:cxnSpLocks/>
          </p:cNvCxnSpPr>
          <p:nvPr/>
        </p:nvCxnSpPr>
        <p:spPr>
          <a:xfrm>
            <a:off x="1445340" y="5129010"/>
            <a:ext cx="0" cy="88589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500928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513A25D-3D9A-1B40-B12C-BCA322924645}"/>
              </a:ext>
            </a:extLst>
          </p:cNvPr>
          <p:cNvSpPr txBox="1"/>
          <p:nvPr/>
        </p:nvSpPr>
        <p:spPr>
          <a:xfrm>
            <a:off x="180000" y="72000"/>
            <a:ext cx="1898460" cy="424728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 Figure 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C9A933E-BDA0-792D-6B3D-4E090682FB0C}"/>
              </a:ext>
            </a:extLst>
          </p:cNvPr>
          <p:cNvSpPr txBox="1"/>
          <p:nvPr/>
        </p:nvSpPr>
        <p:spPr>
          <a:xfrm>
            <a:off x="180000" y="360000"/>
            <a:ext cx="462170" cy="424728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567FCBC-3FA0-6F6F-F62D-BDC8DF998E7E}"/>
              </a:ext>
            </a:extLst>
          </p:cNvPr>
          <p:cNvSpPr txBox="1"/>
          <p:nvPr/>
        </p:nvSpPr>
        <p:spPr>
          <a:xfrm>
            <a:off x="180000" y="2702804"/>
            <a:ext cx="462170" cy="424728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B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76F4FEF-613F-6048-96CC-454C2FC9908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31" b="31"/>
          <a:stretch/>
        </p:blipFill>
        <p:spPr>
          <a:xfrm>
            <a:off x="539966" y="2972856"/>
            <a:ext cx="6300000" cy="158136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DA84D88A-4611-CE2F-1DBA-414BF053941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25217"/>
          <a:stretch/>
        </p:blipFill>
        <p:spPr>
          <a:xfrm>
            <a:off x="539966" y="685916"/>
            <a:ext cx="6300000" cy="150677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C6F9FB9-F4B3-BAA2-027F-473C8A8636CE}"/>
              </a:ext>
            </a:extLst>
          </p:cNvPr>
          <p:cNvSpPr txBox="1"/>
          <p:nvPr/>
        </p:nvSpPr>
        <p:spPr>
          <a:xfrm>
            <a:off x="180000" y="4921178"/>
            <a:ext cx="462170" cy="424728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C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CE928D18-C4F5-7F79-CF85-10C7BA66D077}"/>
              </a:ext>
            </a:extLst>
          </p:cNvPr>
          <p:cNvGrpSpPr/>
          <p:nvPr/>
        </p:nvGrpSpPr>
        <p:grpSpPr>
          <a:xfrm>
            <a:off x="567523" y="5135783"/>
            <a:ext cx="6272443" cy="4503339"/>
            <a:chOff x="192949" y="13052"/>
            <a:chExt cx="9213987" cy="6615238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7458D5F5-1D03-914D-82E2-67ACB5EA0FD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2949" y="638980"/>
              <a:ext cx="8096250" cy="4953000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DF31EDD-A562-B474-E542-CA7EC67B793F}"/>
                </a:ext>
              </a:extLst>
            </p:cNvPr>
            <p:cNvSpPr txBox="1"/>
            <p:nvPr/>
          </p:nvSpPr>
          <p:spPr>
            <a:xfrm>
              <a:off x="2155368" y="13052"/>
              <a:ext cx="7251568" cy="5425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b="1" dirty="0">
                  <a:latin typeface="Arial" panose="020B0604020202020204" pitchFamily="34" charset="0"/>
                  <a:cs typeface="Arial" panose="020B0604020202020204" pitchFamily="34" charset="0"/>
                </a:rPr>
                <a:t>CCNA1 – GFP  expression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9C2CC68B-62B6-6BE6-234A-FE0B9223EC47}"/>
                </a:ext>
              </a:extLst>
            </p:cNvPr>
            <p:cNvSpPr/>
            <p:nvPr/>
          </p:nvSpPr>
          <p:spPr>
            <a:xfrm>
              <a:off x="326571" y="1926384"/>
              <a:ext cx="5985328" cy="242050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AU" dirty="0"/>
                <a:t>GFP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B766A3AD-C2DD-D93C-7DA4-A5CC7CFA3255}"/>
                </a:ext>
              </a:extLst>
            </p:cNvPr>
            <p:cNvSpPr/>
            <p:nvPr/>
          </p:nvSpPr>
          <p:spPr>
            <a:xfrm>
              <a:off x="5286374" y="3082300"/>
              <a:ext cx="1025525" cy="241926"/>
            </a:xfrm>
            <a:prstGeom prst="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AU" dirty="0">
                  <a:solidFill>
                    <a:schemeClr val="tx1"/>
                  </a:solidFill>
                </a:rPr>
                <a:t>GFP</a:t>
              </a: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330BAEAC-E57F-8B23-97D5-65CFE8302E98}"/>
                </a:ext>
              </a:extLst>
            </p:cNvPr>
            <p:cNvSpPr/>
            <p:nvPr/>
          </p:nvSpPr>
          <p:spPr>
            <a:xfrm>
              <a:off x="647699" y="5802537"/>
              <a:ext cx="1357745" cy="320299"/>
            </a:xfrm>
            <a:prstGeom prst="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AU" dirty="0">
                  <a:solidFill>
                    <a:schemeClr val="tx1"/>
                  </a:solidFill>
                </a:rPr>
                <a:t>Weak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A4B221C1-A9F8-4981-5218-7B4536CBBA6F}"/>
                </a:ext>
              </a:extLst>
            </p:cNvPr>
            <p:cNvSpPr/>
            <p:nvPr/>
          </p:nvSpPr>
          <p:spPr>
            <a:xfrm>
              <a:off x="629409" y="6236744"/>
              <a:ext cx="1376035" cy="391546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AU" dirty="0"/>
                <a:t>Strong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40283BFC-9F2C-DEA9-5371-51E22083A349}"/>
                </a:ext>
              </a:extLst>
            </p:cNvPr>
            <p:cNvSpPr/>
            <p:nvPr/>
          </p:nvSpPr>
          <p:spPr>
            <a:xfrm>
              <a:off x="384194" y="697656"/>
              <a:ext cx="1072136" cy="2150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AU" dirty="0"/>
                <a:t>GFP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731701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513A25D-3D9A-1B40-B12C-BCA322924645}"/>
              </a:ext>
            </a:extLst>
          </p:cNvPr>
          <p:cNvSpPr txBox="1"/>
          <p:nvPr/>
        </p:nvSpPr>
        <p:spPr>
          <a:xfrm>
            <a:off x="180000" y="72000"/>
            <a:ext cx="1898460" cy="424728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 Figure 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2D51042-7963-2C41-AF1F-E383892E635E}"/>
              </a:ext>
            </a:extLst>
          </p:cNvPr>
          <p:cNvSpPr txBox="1"/>
          <p:nvPr/>
        </p:nvSpPr>
        <p:spPr>
          <a:xfrm>
            <a:off x="180000" y="388253"/>
            <a:ext cx="462170" cy="424728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359736C-0AC9-D57A-9AB2-B6B3D28C7457}"/>
              </a:ext>
            </a:extLst>
          </p:cNvPr>
          <p:cNvSpPr txBox="1"/>
          <p:nvPr/>
        </p:nvSpPr>
        <p:spPr>
          <a:xfrm>
            <a:off x="450332" y="459686"/>
            <a:ext cx="1526564" cy="332395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Ccna1; X-B x WT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C85FA21A-020F-4084-DFBB-EF438A90B237}"/>
              </a:ext>
            </a:extLst>
          </p:cNvPr>
          <p:cNvSpPr txBox="1"/>
          <p:nvPr/>
        </p:nvSpPr>
        <p:spPr>
          <a:xfrm>
            <a:off x="450332" y="2455449"/>
            <a:ext cx="1526564" cy="332395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Ccna1; X-C x WT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39184014-EDD6-14FD-58B1-5DB858F12382}"/>
              </a:ext>
            </a:extLst>
          </p:cNvPr>
          <p:cNvSpPr txBox="1"/>
          <p:nvPr/>
        </p:nvSpPr>
        <p:spPr>
          <a:xfrm>
            <a:off x="180000" y="2382837"/>
            <a:ext cx="462170" cy="424728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B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1D71A9FC-F2A5-427F-4AEB-3BA1F215A502}"/>
              </a:ext>
            </a:extLst>
          </p:cNvPr>
          <p:cNvSpPr txBox="1"/>
          <p:nvPr/>
        </p:nvSpPr>
        <p:spPr>
          <a:xfrm>
            <a:off x="479531" y="4468040"/>
            <a:ext cx="1449620" cy="332395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Prm1; X-C x WT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163BD8C5-F6E5-11B8-2289-58010442FDD7}"/>
              </a:ext>
            </a:extLst>
          </p:cNvPr>
          <p:cNvSpPr txBox="1"/>
          <p:nvPr/>
        </p:nvSpPr>
        <p:spPr>
          <a:xfrm>
            <a:off x="180000" y="4406621"/>
            <a:ext cx="462170" cy="424728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C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7FE0E7A4-78D0-9C81-0B3F-E9165B41E99E}"/>
              </a:ext>
            </a:extLst>
          </p:cNvPr>
          <p:cNvSpPr txBox="1"/>
          <p:nvPr/>
        </p:nvSpPr>
        <p:spPr>
          <a:xfrm>
            <a:off x="488119" y="6491824"/>
            <a:ext cx="1449620" cy="332395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Stra8; X-C x WT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55A8838D-6930-1E15-B283-B20C7E5C2B32}"/>
              </a:ext>
            </a:extLst>
          </p:cNvPr>
          <p:cNvSpPr txBox="1"/>
          <p:nvPr/>
        </p:nvSpPr>
        <p:spPr>
          <a:xfrm>
            <a:off x="188588" y="6430405"/>
            <a:ext cx="462170" cy="424728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D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48B890C9-EA2E-D908-60ED-08A08E171C3C}"/>
              </a:ext>
            </a:extLst>
          </p:cNvPr>
          <p:cNvSpPr txBox="1"/>
          <p:nvPr/>
        </p:nvSpPr>
        <p:spPr>
          <a:xfrm>
            <a:off x="189066" y="8442556"/>
            <a:ext cx="462170" cy="424728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E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9ACCDC68-A39E-3EF8-A9BB-5CB5FB328504}"/>
              </a:ext>
            </a:extLst>
          </p:cNvPr>
          <p:cNvSpPr txBox="1"/>
          <p:nvPr/>
        </p:nvSpPr>
        <p:spPr>
          <a:xfrm>
            <a:off x="459398" y="8513989"/>
            <a:ext cx="1526564" cy="332395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Ccna1; X-D x WT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986C9C5-DA0F-41A1-3A2D-C9EF1929D47F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2218905" y="656992"/>
            <a:ext cx="2390776" cy="183549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FB8E70D-F65A-3091-403C-EEBC272982A6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/>
          <a:stretch/>
        </p:blipFill>
        <p:spPr>
          <a:xfrm>
            <a:off x="584329" y="788415"/>
            <a:ext cx="1226009" cy="170407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51FAFB4-6A79-0861-9641-B143D2E04111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/>
          <a:stretch/>
        </p:blipFill>
        <p:spPr>
          <a:xfrm>
            <a:off x="2113805" y="2652755"/>
            <a:ext cx="2315671" cy="183549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F1A780D-0846-5860-B3DD-4DDD798D99E2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/>
          <a:stretch/>
        </p:blipFill>
        <p:spPr>
          <a:xfrm>
            <a:off x="581543" y="2785454"/>
            <a:ext cx="1687320" cy="17028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A2C87F1-34D2-29FD-5168-735753E0D3AE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/>
          <a:stretch/>
        </p:blipFill>
        <p:spPr>
          <a:xfrm>
            <a:off x="2187375" y="4665346"/>
            <a:ext cx="1982648" cy="183549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AA9CBB9E-2299-C6C0-FBA9-9C3EC10D9F10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/>
          <a:stretch/>
        </p:blipFill>
        <p:spPr>
          <a:xfrm>
            <a:off x="581543" y="4798045"/>
            <a:ext cx="1339020" cy="17028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648FD2F3-5345-8918-73E3-DEB917E97C57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/>
          <a:stretch/>
        </p:blipFill>
        <p:spPr>
          <a:xfrm>
            <a:off x="2212564" y="6689130"/>
            <a:ext cx="1781285" cy="1835499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AD2F3B7A-10F3-32D6-9F7C-8D405960A302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/>
          <a:stretch/>
        </p:blipFill>
        <p:spPr>
          <a:xfrm>
            <a:off x="595574" y="6821830"/>
            <a:ext cx="1244054" cy="170279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0FB8CEE-EF37-2945-CA8A-6F5CF40F4FA0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/>
          <a:stretch/>
        </p:blipFill>
        <p:spPr>
          <a:xfrm>
            <a:off x="2236762" y="8711295"/>
            <a:ext cx="2184011" cy="1835499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E2527F6F-7A4A-45DA-56A9-4BC8C36442B4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/>
          <a:stretch/>
        </p:blipFill>
        <p:spPr>
          <a:xfrm>
            <a:off x="593396" y="8842718"/>
            <a:ext cx="1226008" cy="1704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29446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513A25D-3D9A-1B40-B12C-BCA322924645}"/>
              </a:ext>
            </a:extLst>
          </p:cNvPr>
          <p:cNvSpPr txBox="1"/>
          <p:nvPr/>
        </p:nvSpPr>
        <p:spPr>
          <a:xfrm>
            <a:off x="180000" y="72000"/>
            <a:ext cx="1962580" cy="424728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 Figure 4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2D51042-7963-2C41-AF1F-E383892E635E}"/>
              </a:ext>
            </a:extLst>
          </p:cNvPr>
          <p:cNvSpPr txBox="1"/>
          <p:nvPr/>
        </p:nvSpPr>
        <p:spPr>
          <a:xfrm>
            <a:off x="113833" y="516670"/>
            <a:ext cx="462170" cy="424728"/>
          </a:xfrm>
          <a:prstGeom prst="rect">
            <a:avLst/>
          </a:prstGeom>
          <a:noFill/>
        </p:spPr>
        <p:txBody>
          <a:bodyPr wrap="none" lIns="146300" tIns="73150" rIns="146300" bIns="73150" rtlCol="0" anchor="t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872417D-B476-49B8-BF5E-7AAD9467C27C}"/>
              </a:ext>
            </a:extLst>
          </p:cNvPr>
          <p:cNvSpPr txBox="1"/>
          <p:nvPr/>
        </p:nvSpPr>
        <p:spPr>
          <a:xfrm>
            <a:off x="114021" y="6407713"/>
            <a:ext cx="462170" cy="424728"/>
          </a:xfrm>
          <a:prstGeom prst="rect">
            <a:avLst/>
          </a:prstGeom>
          <a:noFill/>
        </p:spPr>
        <p:txBody>
          <a:bodyPr wrap="none" lIns="146300" tIns="73150" rIns="146300" bIns="73150" rtlCol="0" anchor="t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B</a:t>
            </a: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47BF9F7-D59F-FD90-F160-2A8FEA97CFD5}"/>
              </a:ext>
            </a:extLst>
          </p:cNvPr>
          <p:cNvSpPr txBox="1"/>
          <p:nvPr/>
        </p:nvSpPr>
        <p:spPr>
          <a:xfrm>
            <a:off x="231388" y="6727992"/>
            <a:ext cx="1513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Ccna1</a:t>
            </a:r>
            <a:r>
              <a:rPr lang="en-AU" sz="1000" baseline="30000" dirty="0"/>
              <a:t>Tg</a:t>
            </a:r>
            <a:r>
              <a:rPr lang="en-AU" sz="1000" dirty="0"/>
              <a:t>; X-</a:t>
            </a:r>
            <a:r>
              <a:rPr lang="en-AU" sz="1000" dirty="0" err="1"/>
              <a:t>D</a:t>
            </a:r>
            <a:r>
              <a:rPr lang="en-AU" sz="1000" baseline="30000" dirty="0" err="1"/>
              <a:t>Tg</a:t>
            </a:r>
            <a:r>
              <a:rPr lang="en-AU" sz="1000" dirty="0"/>
              <a:t> blastocysts</a:t>
            </a:r>
            <a:endParaRPr lang="en-AU" sz="1000" baseline="30000" dirty="0"/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2F1D9ADA-3E3B-C432-2040-7934B7B509F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191" y="619837"/>
            <a:ext cx="5545493" cy="5214293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FD5141D2-D2EA-095C-4CB9-2273A1C67E5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3677" y="7000119"/>
            <a:ext cx="7132320" cy="12194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36634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513A25D-3D9A-1B40-B12C-BCA322924645}"/>
              </a:ext>
            </a:extLst>
          </p:cNvPr>
          <p:cNvSpPr txBox="1"/>
          <p:nvPr/>
        </p:nvSpPr>
        <p:spPr>
          <a:xfrm>
            <a:off x="180000" y="72000"/>
            <a:ext cx="1898460" cy="424728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 Figure 5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2D51042-7963-2C41-AF1F-E383892E635E}"/>
              </a:ext>
            </a:extLst>
          </p:cNvPr>
          <p:cNvSpPr txBox="1"/>
          <p:nvPr/>
        </p:nvSpPr>
        <p:spPr>
          <a:xfrm>
            <a:off x="180000" y="388253"/>
            <a:ext cx="462170" cy="424728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A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E84D2B01-1958-F551-49DF-7C634C6566BA}"/>
              </a:ext>
            </a:extLst>
          </p:cNvPr>
          <p:cNvGrpSpPr/>
          <p:nvPr/>
        </p:nvGrpSpPr>
        <p:grpSpPr>
          <a:xfrm>
            <a:off x="458836" y="812981"/>
            <a:ext cx="7002443" cy="2182419"/>
            <a:chOff x="377557" y="4012631"/>
            <a:chExt cx="7002443" cy="2182419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A5B29ED3-6DBE-23EC-699F-E0A2C56EB0D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17569" y="4179327"/>
              <a:ext cx="5461200" cy="137038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63C87B4-E456-62F4-9AD9-73AACCE3623F}"/>
                </a:ext>
              </a:extLst>
            </p:cNvPr>
            <p:cNvSpPr txBox="1"/>
            <p:nvPr/>
          </p:nvSpPr>
          <p:spPr>
            <a:xfrm>
              <a:off x="462517" y="4147819"/>
              <a:ext cx="36420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3.1.5</a:t>
              </a:r>
              <a:endParaRPr lang="en-AU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2045F82-8870-83D5-BA4F-3667AADB839E}"/>
                </a:ext>
              </a:extLst>
            </p:cNvPr>
            <p:cNvSpPr txBox="1"/>
            <p:nvPr/>
          </p:nvSpPr>
          <p:spPr>
            <a:xfrm>
              <a:off x="377557" y="4012632"/>
              <a:ext cx="54053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b="1" dirty="0"/>
                <a:t>Mouse ID</a:t>
              </a:r>
              <a:endParaRPr lang="en-AU" b="1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2FCDA2C-867D-743B-1058-7BB113B5B72A}"/>
                </a:ext>
              </a:extLst>
            </p:cNvPr>
            <p:cNvSpPr txBox="1"/>
            <p:nvPr/>
          </p:nvSpPr>
          <p:spPr>
            <a:xfrm>
              <a:off x="892886" y="4012632"/>
              <a:ext cx="3722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b="1" dirty="0"/>
                <a:t>Indel</a:t>
              </a:r>
              <a:endParaRPr lang="en-AU" b="1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4B4EFC1-E4BF-2D80-4AA6-B26D22E6552C}"/>
                </a:ext>
              </a:extLst>
            </p:cNvPr>
            <p:cNvSpPr txBox="1"/>
            <p:nvPr/>
          </p:nvSpPr>
          <p:spPr>
            <a:xfrm>
              <a:off x="1240977" y="4012632"/>
              <a:ext cx="65915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b="1" dirty="0"/>
                <a:t>Contribution</a:t>
              </a:r>
              <a:endParaRPr lang="en-AU" b="1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17CA0158-2AA1-ED8B-57A6-C2C787A9222E}"/>
                </a:ext>
              </a:extLst>
            </p:cNvPr>
            <p:cNvSpPr txBox="1"/>
            <p:nvPr/>
          </p:nvSpPr>
          <p:spPr>
            <a:xfrm>
              <a:off x="1842181" y="4012631"/>
              <a:ext cx="54213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b="1" dirty="0"/>
                <a:t>Sequence</a:t>
              </a:r>
              <a:endParaRPr lang="en-AU" b="1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99CEBC1-43BA-E336-93B1-5B524A011227}"/>
                </a:ext>
              </a:extLst>
            </p:cNvPr>
            <p:cNvSpPr txBox="1"/>
            <p:nvPr/>
          </p:nvSpPr>
          <p:spPr>
            <a:xfrm>
              <a:off x="971320" y="4147819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0</a:t>
              </a:r>
              <a:endParaRPr lang="en-AU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09E9103-9883-353B-0AC9-F3AF0B5041DC}"/>
                </a:ext>
              </a:extLst>
            </p:cNvPr>
            <p:cNvSpPr txBox="1"/>
            <p:nvPr/>
          </p:nvSpPr>
          <p:spPr>
            <a:xfrm>
              <a:off x="1379560" y="4147819"/>
              <a:ext cx="38343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100%</a:t>
              </a:r>
              <a:endParaRPr lang="en-AU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E9B1BBA-47D4-2E06-67EE-6AB552A05C42}"/>
                </a:ext>
              </a:extLst>
            </p:cNvPr>
            <p:cNvSpPr txBox="1"/>
            <p:nvPr/>
          </p:nvSpPr>
          <p:spPr>
            <a:xfrm>
              <a:off x="440076" y="4318103"/>
              <a:ext cx="40908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4.5.84</a:t>
              </a:r>
              <a:endParaRPr lang="en-AU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7042128-FDAD-C9D2-58F9-EAD85F5FCF31}"/>
                </a:ext>
              </a:extLst>
            </p:cNvPr>
            <p:cNvSpPr txBox="1"/>
            <p:nvPr/>
          </p:nvSpPr>
          <p:spPr>
            <a:xfrm>
              <a:off x="971320" y="4318103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0</a:t>
              </a:r>
              <a:endParaRPr lang="en-AU" dirty="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737D4E8C-6A9D-1A7B-9E09-2E6A4F3FCEF0}"/>
                </a:ext>
              </a:extLst>
            </p:cNvPr>
            <p:cNvSpPr txBox="1"/>
            <p:nvPr/>
          </p:nvSpPr>
          <p:spPr>
            <a:xfrm>
              <a:off x="1379560" y="4318103"/>
              <a:ext cx="38343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100%</a:t>
              </a:r>
              <a:endParaRPr lang="en-AU" dirty="0"/>
            </a:p>
          </p:txBody>
        </p:sp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1FA5ECC1-2B50-1250-00AC-C972019EB5A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913775" y="4347008"/>
              <a:ext cx="5461200" cy="142245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631A22C-3605-7F83-7BE1-883A54698276}"/>
                </a:ext>
              </a:extLst>
            </p:cNvPr>
            <p:cNvSpPr txBox="1"/>
            <p:nvPr/>
          </p:nvSpPr>
          <p:spPr>
            <a:xfrm>
              <a:off x="472937" y="4549849"/>
              <a:ext cx="34336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2.1d</a:t>
              </a:r>
              <a:endParaRPr lang="en-AU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FA536D8A-C9E7-488C-FAC1-E1615E10E34E}"/>
                </a:ext>
              </a:extLst>
            </p:cNvPr>
            <p:cNvSpPr txBox="1"/>
            <p:nvPr/>
          </p:nvSpPr>
          <p:spPr>
            <a:xfrm>
              <a:off x="971320" y="4549849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0</a:t>
              </a:r>
              <a:endParaRPr lang="en-AU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A332D033-A9B2-D16F-3403-D49A36D80479}"/>
                </a:ext>
              </a:extLst>
            </p:cNvPr>
            <p:cNvSpPr txBox="1"/>
            <p:nvPr/>
          </p:nvSpPr>
          <p:spPr>
            <a:xfrm>
              <a:off x="1379560" y="4549849"/>
              <a:ext cx="38343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100%</a:t>
              </a:r>
              <a:endParaRPr lang="en-AU" dirty="0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BDCF86CE-93EB-19AD-E2B1-A5801FCB3EF8}"/>
                </a:ext>
              </a:extLst>
            </p:cNvPr>
            <p:cNvSpPr txBox="1"/>
            <p:nvPr/>
          </p:nvSpPr>
          <p:spPr>
            <a:xfrm>
              <a:off x="482555" y="4720133"/>
              <a:ext cx="3241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2.1f</a:t>
              </a:r>
              <a:endParaRPr lang="en-AU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6868057-BFE6-EFB6-FF41-3E05A581F6F8}"/>
                </a:ext>
              </a:extLst>
            </p:cNvPr>
            <p:cNvSpPr txBox="1"/>
            <p:nvPr/>
          </p:nvSpPr>
          <p:spPr>
            <a:xfrm>
              <a:off x="971320" y="4720133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0</a:t>
              </a:r>
              <a:endParaRPr lang="en-AU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2E514F8E-E37B-91FB-2969-4107AED3C5A9}"/>
                </a:ext>
              </a:extLst>
            </p:cNvPr>
            <p:cNvSpPr txBox="1"/>
            <p:nvPr/>
          </p:nvSpPr>
          <p:spPr>
            <a:xfrm>
              <a:off x="1379560" y="4720133"/>
              <a:ext cx="38343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100%</a:t>
              </a:r>
              <a:endParaRPr lang="en-AU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4D511D3-6A56-97C8-F48D-646777FC09FA}"/>
                </a:ext>
              </a:extLst>
            </p:cNvPr>
            <p:cNvSpPr txBox="1"/>
            <p:nvPr/>
          </p:nvSpPr>
          <p:spPr>
            <a:xfrm>
              <a:off x="477076" y="4905696"/>
              <a:ext cx="33855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2.1g</a:t>
              </a:r>
              <a:endParaRPr lang="en-AU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94F5BD3D-0AD9-A91B-9318-12DE60809FC2}"/>
                </a:ext>
              </a:extLst>
            </p:cNvPr>
            <p:cNvSpPr txBox="1"/>
            <p:nvPr/>
          </p:nvSpPr>
          <p:spPr>
            <a:xfrm>
              <a:off x="973054" y="4905696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0</a:t>
              </a:r>
              <a:endParaRPr lang="en-AU" dirty="0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485954FB-9EF9-BEC0-3284-6CBB39E75F8E}"/>
                </a:ext>
              </a:extLst>
            </p:cNvPr>
            <p:cNvSpPr txBox="1"/>
            <p:nvPr/>
          </p:nvSpPr>
          <p:spPr>
            <a:xfrm>
              <a:off x="1381294" y="4905696"/>
              <a:ext cx="38343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100%</a:t>
              </a:r>
              <a:endParaRPr lang="en-AU" dirty="0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665450CF-9119-83EF-3129-DE7401621869}"/>
                </a:ext>
              </a:extLst>
            </p:cNvPr>
            <p:cNvSpPr txBox="1"/>
            <p:nvPr/>
          </p:nvSpPr>
          <p:spPr>
            <a:xfrm>
              <a:off x="475473" y="5075980"/>
              <a:ext cx="34176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1.2e</a:t>
              </a:r>
              <a:endParaRPr lang="en-AU" dirty="0"/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57061599-93E5-E7C4-002A-D7FB2A5ABE0E}"/>
                </a:ext>
              </a:extLst>
            </p:cNvPr>
            <p:cNvSpPr txBox="1"/>
            <p:nvPr/>
          </p:nvSpPr>
          <p:spPr>
            <a:xfrm>
              <a:off x="973054" y="5075980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0</a:t>
              </a:r>
              <a:endParaRPr lang="en-AU" dirty="0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54A80AB5-5D4A-1058-EC61-FBDF17863BAD}"/>
                </a:ext>
              </a:extLst>
            </p:cNvPr>
            <p:cNvSpPr txBox="1"/>
            <p:nvPr/>
          </p:nvSpPr>
          <p:spPr>
            <a:xfrm>
              <a:off x="1381294" y="5075980"/>
              <a:ext cx="38343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100%</a:t>
              </a:r>
              <a:endParaRPr lang="en-AU" dirty="0"/>
            </a:p>
          </p:txBody>
        </p:sp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65664CF0-37D2-C819-CCE7-1631A88147E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917569" y="4570897"/>
              <a:ext cx="5461200" cy="147325"/>
            </a:xfrm>
            <a:prstGeom prst="rect">
              <a:avLst/>
            </a:prstGeom>
          </p:spPr>
        </p:pic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EB4D0BF0-B05B-8251-AD97-71AD7F40F27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917569" y="4746837"/>
              <a:ext cx="5461200" cy="147462"/>
            </a:xfrm>
            <a:prstGeom prst="rect">
              <a:avLst/>
            </a:prstGeom>
          </p:spPr>
        </p:pic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C6B3ADAB-0B94-78E3-9E4D-FD87A340040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917569" y="4930350"/>
              <a:ext cx="5461200" cy="142245"/>
            </a:xfrm>
            <a:prstGeom prst="rect">
              <a:avLst/>
            </a:prstGeom>
          </p:spPr>
        </p:pic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9768D976-3299-EE23-E8C5-057885B81B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t="67057"/>
            <a:stretch/>
          </p:blipFill>
          <p:spPr>
            <a:xfrm>
              <a:off x="1917569" y="5474653"/>
              <a:ext cx="5461200" cy="122400"/>
            </a:xfrm>
            <a:prstGeom prst="rect">
              <a:avLst/>
            </a:prstGeom>
          </p:spPr>
        </p:pic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EDE9039D-8A2B-020C-A9DA-8DDDAC0398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23" t="34882" r="-23" b="32175"/>
            <a:stretch/>
          </p:blipFill>
          <p:spPr>
            <a:xfrm>
              <a:off x="1917569" y="5297752"/>
              <a:ext cx="5461200" cy="122400"/>
            </a:xfrm>
            <a:prstGeom prst="rect">
              <a:avLst/>
            </a:prstGeom>
          </p:spPr>
        </p:pic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19A891CF-E139-5681-2A42-9C845C369BF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23" t="-1" r="-23" b="65119"/>
            <a:stretch/>
          </p:blipFill>
          <p:spPr>
            <a:xfrm>
              <a:off x="1918800" y="5110851"/>
              <a:ext cx="5461200" cy="129600"/>
            </a:xfrm>
            <a:prstGeom prst="rect">
              <a:avLst/>
            </a:prstGeom>
          </p:spPr>
        </p:pic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0AC73A62-1661-5858-65AF-6B8AD765D405}"/>
                </a:ext>
              </a:extLst>
            </p:cNvPr>
            <p:cNvSpPr txBox="1"/>
            <p:nvPr/>
          </p:nvSpPr>
          <p:spPr>
            <a:xfrm>
              <a:off x="955140" y="5260836"/>
              <a:ext cx="25680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-1</a:t>
              </a:r>
              <a:endParaRPr lang="en-AU" dirty="0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BAE9046A-E329-A8C6-9475-4D7A8B13795F}"/>
                </a:ext>
              </a:extLst>
            </p:cNvPr>
            <p:cNvSpPr txBox="1"/>
            <p:nvPr/>
          </p:nvSpPr>
          <p:spPr>
            <a:xfrm>
              <a:off x="1421890" y="5260836"/>
              <a:ext cx="2936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3%</a:t>
              </a:r>
              <a:endParaRPr lang="en-AU" dirty="0"/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2A15F58A-E922-A900-6EC9-CB5DD038807C}"/>
                </a:ext>
              </a:extLst>
            </p:cNvPr>
            <p:cNvSpPr txBox="1"/>
            <p:nvPr/>
          </p:nvSpPr>
          <p:spPr>
            <a:xfrm>
              <a:off x="946323" y="5431120"/>
              <a:ext cx="27443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+1</a:t>
              </a:r>
              <a:endParaRPr lang="en-AU" dirty="0"/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434EA64C-0C60-4B0B-AA3C-9CBDDEF7E85F}"/>
                </a:ext>
              </a:extLst>
            </p:cNvPr>
            <p:cNvSpPr txBox="1"/>
            <p:nvPr/>
          </p:nvSpPr>
          <p:spPr>
            <a:xfrm>
              <a:off x="1421890" y="5431120"/>
              <a:ext cx="2936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1%</a:t>
              </a:r>
              <a:endParaRPr lang="en-AU" dirty="0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A0D0EAD2-CC14-7865-8632-17B73B64BEDE}"/>
                </a:ext>
              </a:extLst>
            </p:cNvPr>
            <p:cNvSpPr txBox="1"/>
            <p:nvPr/>
          </p:nvSpPr>
          <p:spPr>
            <a:xfrm>
              <a:off x="455312" y="5643861"/>
              <a:ext cx="36420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1.1.9</a:t>
              </a:r>
              <a:endParaRPr lang="en-AU" dirty="0"/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F66F5406-ED72-8CBC-F2DF-EC83C4D9C823}"/>
                </a:ext>
              </a:extLst>
            </p:cNvPr>
            <p:cNvSpPr txBox="1"/>
            <p:nvPr/>
          </p:nvSpPr>
          <p:spPr>
            <a:xfrm>
              <a:off x="964113" y="5643861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0</a:t>
              </a:r>
              <a:endParaRPr lang="en-AU" dirty="0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8639C1CE-D342-015C-03EE-043B2586C8FA}"/>
                </a:ext>
              </a:extLst>
            </p:cNvPr>
            <p:cNvSpPr txBox="1"/>
            <p:nvPr/>
          </p:nvSpPr>
          <p:spPr>
            <a:xfrm>
              <a:off x="1372353" y="5643861"/>
              <a:ext cx="38343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100%</a:t>
              </a:r>
              <a:endParaRPr lang="en-AU" dirty="0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D13AC421-E58C-4721-B6FB-F296EAA09BEF}"/>
                </a:ext>
              </a:extLst>
            </p:cNvPr>
            <p:cNvSpPr txBox="1"/>
            <p:nvPr/>
          </p:nvSpPr>
          <p:spPr>
            <a:xfrm>
              <a:off x="432870" y="5814145"/>
              <a:ext cx="40908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2.1.23</a:t>
              </a:r>
              <a:endParaRPr lang="en-AU" dirty="0"/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BD6D6F20-360D-DA4F-8FC0-AAF839A0EF74}"/>
                </a:ext>
              </a:extLst>
            </p:cNvPr>
            <p:cNvSpPr txBox="1"/>
            <p:nvPr/>
          </p:nvSpPr>
          <p:spPr>
            <a:xfrm>
              <a:off x="964113" y="5814145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0</a:t>
              </a:r>
              <a:endParaRPr lang="en-AU" dirty="0"/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E2BB68D8-ACAA-8029-EEDF-564A35131D9C}"/>
                </a:ext>
              </a:extLst>
            </p:cNvPr>
            <p:cNvSpPr txBox="1"/>
            <p:nvPr/>
          </p:nvSpPr>
          <p:spPr>
            <a:xfrm>
              <a:off x="1372353" y="5814145"/>
              <a:ext cx="38343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100%</a:t>
              </a:r>
              <a:endParaRPr lang="en-AU" dirty="0"/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54A733F0-4A6D-9E8F-5C2D-2E38812B7588}"/>
                </a:ext>
              </a:extLst>
            </p:cNvPr>
            <p:cNvSpPr txBox="1"/>
            <p:nvPr/>
          </p:nvSpPr>
          <p:spPr>
            <a:xfrm>
              <a:off x="434604" y="5994995"/>
              <a:ext cx="40908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2.1.24</a:t>
              </a:r>
              <a:endParaRPr lang="en-AU" dirty="0"/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50DF4D55-61DC-C671-D353-BD3A483C8D6B}"/>
                </a:ext>
              </a:extLst>
            </p:cNvPr>
            <p:cNvSpPr txBox="1"/>
            <p:nvPr/>
          </p:nvSpPr>
          <p:spPr>
            <a:xfrm>
              <a:off x="965847" y="5994995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0</a:t>
              </a:r>
              <a:endParaRPr lang="en-AU" dirty="0"/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6B91399C-1291-5820-797D-1ADA54C870E5}"/>
                </a:ext>
              </a:extLst>
            </p:cNvPr>
            <p:cNvSpPr txBox="1"/>
            <p:nvPr/>
          </p:nvSpPr>
          <p:spPr>
            <a:xfrm>
              <a:off x="1374087" y="5994995"/>
              <a:ext cx="38343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700" dirty="0"/>
                <a:t>100%</a:t>
              </a:r>
              <a:endParaRPr lang="en-AU" dirty="0"/>
            </a:p>
          </p:txBody>
        </p:sp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03DBA826-F2E3-37C0-162A-A748614DC77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23" r="-23" b="5604"/>
            <a:stretch/>
          </p:blipFill>
          <p:spPr>
            <a:xfrm>
              <a:off x="1918800" y="5680828"/>
              <a:ext cx="5461200" cy="129600"/>
            </a:xfrm>
            <a:prstGeom prst="rect">
              <a:avLst/>
            </a:prstGeom>
          </p:spPr>
        </p:pic>
        <p:pic>
          <p:nvPicPr>
            <p:cNvPr id="58" name="Picture 57">
              <a:extLst>
                <a:ext uri="{FF2B5EF4-FFF2-40B4-BE49-F238E27FC236}">
                  <a16:creationId xmlns:a16="http://schemas.microsoft.com/office/drawing/2014/main" id="{C508F013-0B70-BCB6-F7AC-38A18C718ADA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918800" y="5847399"/>
              <a:ext cx="5461200" cy="147462"/>
            </a:xfrm>
            <a:prstGeom prst="rect">
              <a:avLst/>
            </a:prstGeom>
          </p:spPr>
        </p:pic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F2A928D2-10B0-9B1E-0F7B-4AE5A2F221A6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915006" y="6020773"/>
              <a:ext cx="5461200" cy="137037"/>
            </a:xfrm>
            <a:prstGeom prst="rect">
              <a:avLst/>
            </a:prstGeom>
          </p:spPr>
        </p:pic>
      </p:grpSp>
      <p:sp>
        <p:nvSpPr>
          <p:cNvPr id="63" name="TextBox 62">
            <a:extLst>
              <a:ext uri="{FF2B5EF4-FFF2-40B4-BE49-F238E27FC236}">
                <a16:creationId xmlns:a16="http://schemas.microsoft.com/office/drawing/2014/main" id="{F867236E-DBE9-4A70-69F8-C5E28D3E43B4}"/>
              </a:ext>
            </a:extLst>
          </p:cNvPr>
          <p:cNvSpPr txBox="1"/>
          <p:nvPr/>
        </p:nvSpPr>
        <p:spPr>
          <a:xfrm>
            <a:off x="460278" y="477876"/>
            <a:ext cx="2821790" cy="317006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sz="1100" dirty="0">
                <a:latin typeface="Arial"/>
                <a:cs typeface="Arial"/>
              </a:rPr>
              <a:t>Sperm from sires - X chromosome indel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AA216E1-03A2-E87E-8D3E-45449F7A85B4}"/>
              </a:ext>
            </a:extLst>
          </p:cNvPr>
          <p:cNvSpPr txBox="1"/>
          <p:nvPr/>
        </p:nvSpPr>
        <p:spPr>
          <a:xfrm>
            <a:off x="460278" y="3256232"/>
            <a:ext cx="3506273" cy="317006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sz="1100" dirty="0">
                <a:latin typeface="Arial"/>
                <a:cs typeface="Arial"/>
              </a:rPr>
              <a:t>Male experimental offspring - X chromosome indels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8BEDF20C-1FF0-7B0D-0329-3C58CD88B729}"/>
              </a:ext>
            </a:extLst>
          </p:cNvPr>
          <p:cNvSpPr txBox="1"/>
          <p:nvPr/>
        </p:nvSpPr>
        <p:spPr>
          <a:xfrm>
            <a:off x="180000" y="3149173"/>
            <a:ext cx="462170" cy="424728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B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FC15B7DE-D384-BAE4-0CD3-7F52D2F6A1E4}"/>
              </a:ext>
            </a:extLst>
          </p:cNvPr>
          <p:cNvSpPr txBox="1"/>
          <p:nvPr/>
        </p:nvSpPr>
        <p:spPr>
          <a:xfrm>
            <a:off x="460278" y="4485324"/>
            <a:ext cx="3866948" cy="317006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sz="1100" dirty="0">
                <a:latin typeface="Arial"/>
                <a:cs typeface="Arial"/>
              </a:rPr>
              <a:t>Female experimental offspring - no X chromosome indels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E7F8240D-A759-5CC3-D71A-2EBCACCBD4F3}"/>
              </a:ext>
            </a:extLst>
          </p:cNvPr>
          <p:cNvSpPr txBox="1"/>
          <p:nvPr/>
        </p:nvSpPr>
        <p:spPr>
          <a:xfrm>
            <a:off x="180000" y="4404403"/>
            <a:ext cx="462170" cy="424728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C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C8C7891F-130B-824A-225C-44E6504AC5AF}"/>
              </a:ext>
            </a:extLst>
          </p:cNvPr>
          <p:cNvSpPr txBox="1"/>
          <p:nvPr/>
        </p:nvSpPr>
        <p:spPr>
          <a:xfrm rot="16200000">
            <a:off x="6570" y="2568546"/>
            <a:ext cx="8691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Stra8</a:t>
            </a:r>
            <a:r>
              <a:rPr lang="en-AU" sz="1000" baseline="30000" dirty="0"/>
              <a:t>Tg</a:t>
            </a:r>
            <a:r>
              <a:rPr lang="en-AU" sz="1000" dirty="0"/>
              <a:t>; X-</a:t>
            </a:r>
            <a:r>
              <a:rPr lang="en-AU" sz="1000" dirty="0" err="1"/>
              <a:t>C</a:t>
            </a:r>
            <a:r>
              <a:rPr lang="en-AU" sz="1000" baseline="30000" dirty="0" err="1"/>
              <a:t>Tg</a:t>
            </a:r>
            <a:endParaRPr lang="en-AU" sz="1000" baseline="300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7931C00-F054-69C7-EB6A-1C7ED29C2C01}"/>
              </a:ext>
            </a:extLst>
          </p:cNvPr>
          <p:cNvSpPr txBox="1"/>
          <p:nvPr/>
        </p:nvSpPr>
        <p:spPr>
          <a:xfrm rot="16200000">
            <a:off x="8975" y="1803011"/>
            <a:ext cx="8643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Prm1</a:t>
            </a:r>
            <a:r>
              <a:rPr lang="en-AU" sz="1000" baseline="30000" dirty="0"/>
              <a:t>Tg</a:t>
            </a:r>
            <a:r>
              <a:rPr lang="en-AU" sz="1000" dirty="0"/>
              <a:t>; X-</a:t>
            </a:r>
            <a:r>
              <a:rPr lang="en-AU" sz="1000" dirty="0" err="1"/>
              <a:t>C</a:t>
            </a:r>
            <a:r>
              <a:rPr lang="en-AU" sz="1000" baseline="30000" dirty="0" err="1"/>
              <a:t>Tg</a:t>
            </a:r>
            <a:endParaRPr lang="en-AU" sz="1000" baseline="30000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A02D79C-869E-090A-D608-AA3FCBDDCE79}"/>
              </a:ext>
            </a:extLst>
          </p:cNvPr>
          <p:cNvSpPr txBox="1"/>
          <p:nvPr/>
        </p:nvSpPr>
        <p:spPr>
          <a:xfrm rot="16200000">
            <a:off x="220571" y="1012795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X-</a:t>
            </a:r>
            <a:r>
              <a:rPr lang="en-AU" sz="1000" dirty="0" err="1"/>
              <a:t>C</a:t>
            </a:r>
            <a:r>
              <a:rPr lang="en-AU" sz="1000" baseline="30000" dirty="0" err="1"/>
              <a:t>Tg</a:t>
            </a:r>
            <a:endParaRPr lang="en-AU" sz="1000" baseline="30000" dirty="0"/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49BBF7F2-A53F-38B0-F69C-D7FAB66E71C2}"/>
              </a:ext>
            </a:extLst>
          </p:cNvPr>
          <p:cNvCxnSpPr>
            <a:cxnSpLocks/>
          </p:cNvCxnSpPr>
          <p:nvPr/>
        </p:nvCxnSpPr>
        <p:spPr>
          <a:xfrm>
            <a:off x="515440" y="1011247"/>
            <a:ext cx="1819" cy="252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D4FEEFF3-F296-920A-74D6-4992709D9573}"/>
              </a:ext>
            </a:extLst>
          </p:cNvPr>
          <p:cNvCxnSpPr>
            <a:cxnSpLocks/>
          </p:cNvCxnSpPr>
          <p:nvPr/>
        </p:nvCxnSpPr>
        <p:spPr>
          <a:xfrm>
            <a:off x="516349" y="1423913"/>
            <a:ext cx="0" cy="936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7773BE1A-C064-230D-F35D-7CE2A18DD112}"/>
              </a:ext>
            </a:extLst>
          </p:cNvPr>
          <p:cNvCxnSpPr>
            <a:cxnSpLocks/>
          </p:cNvCxnSpPr>
          <p:nvPr/>
        </p:nvCxnSpPr>
        <p:spPr>
          <a:xfrm flipH="1">
            <a:off x="515380" y="2541201"/>
            <a:ext cx="1938" cy="390999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D1C6EE71-5FD0-354A-6419-EA509CBD5D57}"/>
              </a:ext>
            </a:extLst>
          </p:cNvPr>
          <p:cNvSpPr txBox="1"/>
          <p:nvPr/>
        </p:nvSpPr>
        <p:spPr>
          <a:xfrm rot="16200000">
            <a:off x="-40498" y="3927796"/>
            <a:ext cx="9124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Ccna1</a:t>
            </a:r>
            <a:r>
              <a:rPr lang="en-AU" sz="1000" baseline="30000" dirty="0"/>
              <a:t>Tg</a:t>
            </a:r>
            <a:r>
              <a:rPr lang="en-AU" sz="1000" dirty="0"/>
              <a:t>; X-</a:t>
            </a:r>
            <a:r>
              <a:rPr lang="en-AU" sz="1000" dirty="0" err="1"/>
              <a:t>D</a:t>
            </a:r>
            <a:r>
              <a:rPr lang="en-AU" sz="1000" baseline="30000" dirty="0" err="1"/>
              <a:t>Tg</a:t>
            </a:r>
            <a:endParaRPr lang="en-AU" sz="1000" baseline="30000" dirty="0"/>
          </a:p>
        </p:txBody>
      </p: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6FA21E73-D0E1-D520-B767-2FA658DF6346}"/>
              </a:ext>
            </a:extLst>
          </p:cNvPr>
          <p:cNvCxnSpPr>
            <a:cxnSpLocks/>
          </p:cNvCxnSpPr>
          <p:nvPr/>
        </p:nvCxnSpPr>
        <p:spPr>
          <a:xfrm flipH="1">
            <a:off x="489952" y="3900451"/>
            <a:ext cx="1938" cy="390999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EE824218-CC39-9A4E-8881-A52155B9CAEA}"/>
              </a:ext>
            </a:extLst>
          </p:cNvPr>
          <p:cNvSpPr txBox="1"/>
          <p:nvPr/>
        </p:nvSpPr>
        <p:spPr>
          <a:xfrm rot="16200000">
            <a:off x="-37829" y="5146093"/>
            <a:ext cx="8643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Prm1</a:t>
            </a:r>
            <a:r>
              <a:rPr lang="en-AU" sz="1000" baseline="30000" dirty="0"/>
              <a:t>Tg</a:t>
            </a:r>
            <a:r>
              <a:rPr lang="en-AU" sz="1000" dirty="0"/>
              <a:t>; X-</a:t>
            </a:r>
            <a:r>
              <a:rPr lang="en-AU" sz="1000" dirty="0" err="1"/>
              <a:t>C</a:t>
            </a:r>
            <a:r>
              <a:rPr lang="en-AU" sz="1000" baseline="30000" dirty="0" err="1"/>
              <a:t>Tg</a:t>
            </a:r>
            <a:endParaRPr lang="en-AU" sz="1000" baseline="30000" dirty="0"/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4EC2C52B-9F82-3834-25F0-1BC0480F58B2}"/>
              </a:ext>
            </a:extLst>
          </p:cNvPr>
          <p:cNvCxnSpPr>
            <a:cxnSpLocks/>
          </p:cNvCxnSpPr>
          <p:nvPr/>
        </p:nvCxnSpPr>
        <p:spPr>
          <a:xfrm>
            <a:off x="517698" y="5025191"/>
            <a:ext cx="0" cy="576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D1E95DE1-742E-E1D6-83C3-EE3E2CEFFD8D}"/>
              </a:ext>
            </a:extLst>
          </p:cNvPr>
          <p:cNvSpPr txBox="1"/>
          <p:nvPr/>
        </p:nvSpPr>
        <p:spPr>
          <a:xfrm rot="16200000">
            <a:off x="-35919" y="5975008"/>
            <a:ext cx="8595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Stra8</a:t>
            </a:r>
            <a:r>
              <a:rPr lang="en-AU" sz="1000" baseline="30000" dirty="0"/>
              <a:t>Tg</a:t>
            </a:r>
            <a:r>
              <a:rPr lang="en-AU" sz="1000" dirty="0"/>
              <a:t>; X-</a:t>
            </a:r>
            <a:r>
              <a:rPr lang="en-AU" sz="1000" dirty="0" err="1"/>
              <a:t>C</a:t>
            </a:r>
            <a:r>
              <a:rPr lang="en-AU" sz="1000" baseline="30000" dirty="0" err="1"/>
              <a:t>Tg</a:t>
            </a:r>
            <a:endParaRPr lang="en-AU" sz="1000" baseline="30000" dirty="0"/>
          </a:p>
        </p:txBody>
      </p: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150DEBD6-F59C-7896-FF49-2897CF4F3407}"/>
              </a:ext>
            </a:extLst>
          </p:cNvPr>
          <p:cNvCxnSpPr>
            <a:cxnSpLocks/>
          </p:cNvCxnSpPr>
          <p:nvPr/>
        </p:nvCxnSpPr>
        <p:spPr>
          <a:xfrm>
            <a:off x="517698" y="5761345"/>
            <a:ext cx="0" cy="576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D37100BB-8E5A-514B-96E1-A20DE292EFB6}"/>
              </a:ext>
            </a:extLst>
          </p:cNvPr>
          <p:cNvSpPr txBox="1"/>
          <p:nvPr/>
        </p:nvSpPr>
        <p:spPr>
          <a:xfrm rot="16200000">
            <a:off x="-57065" y="6837112"/>
            <a:ext cx="9028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Ccna1</a:t>
            </a:r>
            <a:r>
              <a:rPr lang="en-AU" sz="1000" baseline="30000" dirty="0"/>
              <a:t>Tg</a:t>
            </a:r>
            <a:r>
              <a:rPr lang="en-AU" sz="1000" dirty="0"/>
              <a:t>; X-</a:t>
            </a:r>
            <a:r>
              <a:rPr lang="en-AU" sz="1000" dirty="0" err="1"/>
              <a:t>C</a:t>
            </a:r>
            <a:r>
              <a:rPr lang="en-AU" sz="1000" baseline="30000" dirty="0" err="1"/>
              <a:t>Tg</a:t>
            </a:r>
            <a:endParaRPr lang="en-AU" sz="1000" baseline="30000" dirty="0"/>
          </a:p>
        </p:txBody>
      </p: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725EE720-B475-813E-AD16-7BB0AF3428E8}"/>
              </a:ext>
            </a:extLst>
          </p:cNvPr>
          <p:cNvCxnSpPr>
            <a:cxnSpLocks/>
          </p:cNvCxnSpPr>
          <p:nvPr/>
        </p:nvCxnSpPr>
        <p:spPr>
          <a:xfrm>
            <a:off x="517698" y="6716210"/>
            <a:ext cx="0" cy="576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6E90169F-B507-B7B9-FEC9-6C2D79FEDAF9}"/>
              </a:ext>
            </a:extLst>
          </p:cNvPr>
          <p:cNvSpPr txBox="1"/>
          <p:nvPr/>
        </p:nvSpPr>
        <p:spPr>
          <a:xfrm rot="16200000">
            <a:off x="-62368" y="7752352"/>
            <a:ext cx="9124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Ccna1</a:t>
            </a:r>
            <a:r>
              <a:rPr lang="en-AU" sz="1000" baseline="30000" dirty="0"/>
              <a:t>Tg</a:t>
            </a:r>
            <a:r>
              <a:rPr lang="en-AU" sz="1000" dirty="0"/>
              <a:t>; X-</a:t>
            </a:r>
            <a:r>
              <a:rPr lang="en-AU" sz="1000" dirty="0" err="1"/>
              <a:t>D</a:t>
            </a:r>
            <a:r>
              <a:rPr lang="en-AU" sz="1000" baseline="30000" dirty="0" err="1"/>
              <a:t>Tg</a:t>
            </a:r>
            <a:endParaRPr lang="en-AU" sz="1000" baseline="30000" dirty="0"/>
          </a:p>
        </p:txBody>
      </p: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3F388F88-A566-CE8E-6F66-41F18D09AEB3}"/>
              </a:ext>
            </a:extLst>
          </p:cNvPr>
          <p:cNvCxnSpPr>
            <a:cxnSpLocks/>
          </p:cNvCxnSpPr>
          <p:nvPr/>
        </p:nvCxnSpPr>
        <p:spPr>
          <a:xfrm>
            <a:off x="517698" y="7538689"/>
            <a:ext cx="0" cy="576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Picture 10">
            <a:extLst>
              <a:ext uri="{FF2B5EF4-FFF2-40B4-BE49-F238E27FC236}">
                <a16:creationId xmlns:a16="http://schemas.microsoft.com/office/drawing/2014/main" id="{733C8841-7685-14FB-8BB5-BE709BCB2348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3247" r="6557"/>
          <a:stretch/>
        </p:blipFill>
        <p:spPr>
          <a:xfrm>
            <a:off x="514148" y="3681668"/>
            <a:ext cx="6595737" cy="698346"/>
          </a:xfrm>
          <a:prstGeom prst="rect">
            <a:avLst/>
          </a:prstGeom>
        </p:spPr>
      </p:pic>
      <p:pic>
        <p:nvPicPr>
          <p:cNvPr id="71" name="Picture 70">
            <a:extLst>
              <a:ext uri="{FF2B5EF4-FFF2-40B4-BE49-F238E27FC236}">
                <a16:creationId xmlns:a16="http://schemas.microsoft.com/office/drawing/2014/main" id="{3E3E3F54-3166-13EE-26F3-4129736672E3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3120" r="9632"/>
          <a:stretch/>
        </p:blipFill>
        <p:spPr>
          <a:xfrm>
            <a:off x="516681" y="4789251"/>
            <a:ext cx="6595736" cy="915190"/>
          </a:xfrm>
          <a:prstGeom prst="rect">
            <a:avLst/>
          </a:prstGeom>
        </p:spPr>
      </p:pic>
      <p:pic>
        <p:nvPicPr>
          <p:cNvPr id="73" name="Picture 72">
            <a:extLst>
              <a:ext uri="{FF2B5EF4-FFF2-40B4-BE49-F238E27FC236}">
                <a16:creationId xmlns:a16="http://schemas.microsoft.com/office/drawing/2014/main" id="{E0AE10B9-2C41-4A51-FA1F-526A93950F8B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3120" r="9632"/>
          <a:stretch/>
        </p:blipFill>
        <p:spPr>
          <a:xfrm>
            <a:off x="516678" y="5770396"/>
            <a:ext cx="6595737" cy="721265"/>
          </a:xfrm>
          <a:prstGeom prst="rect">
            <a:avLst/>
          </a:prstGeom>
        </p:spPr>
      </p:pic>
      <p:pic>
        <p:nvPicPr>
          <p:cNvPr id="75" name="Picture 74">
            <a:extLst>
              <a:ext uri="{FF2B5EF4-FFF2-40B4-BE49-F238E27FC236}">
                <a16:creationId xmlns:a16="http://schemas.microsoft.com/office/drawing/2014/main" id="{C4E242F7-5A82-7D3A-1D76-FDBFA5F2CE7D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3120" r="9632"/>
          <a:stretch/>
        </p:blipFill>
        <p:spPr>
          <a:xfrm>
            <a:off x="516678" y="6608226"/>
            <a:ext cx="6595737" cy="721265"/>
          </a:xfrm>
          <a:prstGeom prst="rect">
            <a:avLst/>
          </a:prstGeom>
        </p:spPr>
      </p:pic>
      <p:pic>
        <p:nvPicPr>
          <p:cNvPr id="76" name="Picture 75">
            <a:extLst>
              <a:ext uri="{FF2B5EF4-FFF2-40B4-BE49-F238E27FC236}">
                <a16:creationId xmlns:a16="http://schemas.microsoft.com/office/drawing/2014/main" id="{F7A8ABD8-E9FC-B502-E7F9-4EC2D4E19883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3143" t="19921" r="9608"/>
          <a:stretch/>
        </p:blipFill>
        <p:spPr>
          <a:xfrm>
            <a:off x="516678" y="7446056"/>
            <a:ext cx="6595737" cy="7212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98200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EF23812-2A14-3853-DB3D-F27C27BF2F26}"/>
              </a:ext>
            </a:extLst>
          </p:cNvPr>
          <p:cNvSpPr txBox="1"/>
          <p:nvPr/>
        </p:nvSpPr>
        <p:spPr>
          <a:xfrm>
            <a:off x="180000" y="72000"/>
            <a:ext cx="4629914" cy="424728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 Table 1 – gRNA used in this study</a:t>
            </a:r>
          </a:p>
        </p:txBody>
      </p:sp>
      <p:graphicFrame>
        <p:nvGraphicFramePr>
          <p:cNvPr id="5" name="Table 5">
            <a:extLst>
              <a:ext uri="{FF2B5EF4-FFF2-40B4-BE49-F238E27FC236}">
                <a16:creationId xmlns:a16="http://schemas.microsoft.com/office/drawing/2014/main" id="{E8AC1FEE-B8AC-B396-70D9-DD11D2E9C07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65406841"/>
              </p:ext>
            </p:extLst>
          </p:nvPr>
        </p:nvGraphicFramePr>
        <p:xfrm>
          <a:off x="345546" y="832838"/>
          <a:ext cx="6478587" cy="243231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075921">
                  <a:extLst>
                    <a:ext uri="{9D8B030D-6E8A-4147-A177-3AD203B41FA5}">
                      <a16:colId xmlns:a16="http://schemas.microsoft.com/office/drawing/2014/main" val="648576118"/>
                    </a:ext>
                  </a:extLst>
                </a:gridCol>
                <a:gridCol w="4402666">
                  <a:extLst>
                    <a:ext uri="{9D8B030D-6E8A-4147-A177-3AD203B41FA5}">
                      <a16:colId xmlns:a16="http://schemas.microsoft.com/office/drawing/2014/main" val="1275282691"/>
                    </a:ext>
                  </a:extLst>
                </a:gridCol>
              </a:tblGrid>
              <a:tr h="347474">
                <a:tc>
                  <a:txBody>
                    <a:bodyPr/>
                    <a:lstStyle/>
                    <a:p>
                      <a:r>
                        <a:rPr lang="en-AU" b="1" dirty="0"/>
                        <a:t>sgRN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b="1" dirty="0"/>
                        <a:t>Sequenc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03538268"/>
                  </a:ext>
                </a:extLst>
              </a:tr>
              <a:tr h="347474">
                <a:tc>
                  <a:txBody>
                    <a:bodyPr/>
                    <a:lstStyle/>
                    <a:p>
                      <a:r>
                        <a:rPr lang="en-AU" dirty="0"/>
                        <a:t>X-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dirty="0"/>
                        <a:t>GCTTGGTTAGGGTGAGTGC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9555678"/>
                  </a:ext>
                </a:extLst>
              </a:tr>
              <a:tr h="347474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dirty="0"/>
                        <a:t>X-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600" u="none" strike="noStrike" dirty="0">
                          <a:effectLst/>
                        </a:rPr>
                        <a:t>CTGGGAATTAGAATGCCAGA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33900956"/>
                  </a:ext>
                </a:extLst>
              </a:tr>
              <a:tr h="347474">
                <a:tc>
                  <a:txBody>
                    <a:bodyPr/>
                    <a:lstStyle/>
                    <a:p>
                      <a:r>
                        <a:rPr lang="en-AU" dirty="0"/>
                        <a:t>X-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600" u="none" strike="noStrike" dirty="0">
                          <a:effectLst/>
                        </a:rPr>
                        <a:t>TAAGTGCTGTGTGCTGCTAC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95066961"/>
                  </a:ext>
                </a:extLst>
              </a:tr>
              <a:tr h="347474">
                <a:tc>
                  <a:txBody>
                    <a:bodyPr/>
                    <a:lstStyle/>
                    <a:p>
                      <a:r>
                        <a:rPr lang="en-AU" dirty="0"/>
                        <a:t>Tyrosina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dirty="0"/>
                        <a:t>TCAGTTCCCCTTCAAAGGGG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04446905"/>
                  </a:ext>
                </a:extLst>
              </a:tr>
              <a:tr h="347474">
                <a:tc>
                  <a:txBody>
                    <a:bodyPr/>
                    <a:lstStyle/>
                    <a:p>
                      <a:r>
                        <a:rPr lang="en-AU" dirty="0"/>
                        <a:t>Neomyc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dirty="0"/>
                        <a:t>GGCAGCGCGGCTATCGTGG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76767858"/>
                  </a:ext>
                </a:extLst>
              </a:tr>
              <a:tr h="347474">
                <a:tc>
                  <a:txBody>
                    <a:bodyPr/>
                    <a:lstStyle/>
                    <a:p>
                      <a:r>
                        <a:rPr lang="en-AU" dirty="0" err="1"/>
                        <a:t>mCherry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dirty="0"/>
                        <a:t>GGCCACGAGTTCGAGATCG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8033753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840969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0FD90A3-9E7E-0290-8F76-A609461E3362}"/>
              </a:ext>
            </a:extLst>
          </p:cNvPr>
          <p:cNvSpPr txBox="1"/>
          <p:nvPr/>
        </p:nvSpPr>
        <p:spPr>
          <a:xfrm>
            <a:off x="180000" y="72000"/>
            <a:ext cx="5831140" cy="424728"/>
          </a:xfrm>
          <a:prstGeom prst="rect">
            <a:avLst/>
          </a:prstGeom>
          <a:noFill/>
        </p:spPr>
        <p:txBody>
          <a:bodyPr wrap="none" lIns="146300" tIns="73150" rIns="146300" bIns="73150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 Table 2 – oligonucleotides used in </a:t>
            </a:r>
            <a:r>
              <a:rPr lang="en-US" b="1">
                <a:latin typeface="Arial"/>
                <a:cs typeface="Arial"/>
              </a:rPr>
              <a:t>this study</a:t>
            </a:r>
            <a:endParaRPr lang="en-US" b="1" dirty="0">
              <a:latin typeface="Arial"/>
              <a:cs typeface="Arial"/>
            </a:endParaRPr>
          </a:p>
        </p:txBody>
      </p:sp>
      <p:graphicFrame>
        <p:nvGraphicFramePr>
          <p:cNvPr id="5" name="Table 5">
            <a:extLst>
              <a:ext uri="{FF2B5EF4-FFF2-40B4-BE49-F238E27FC236}">
                <a16:creationId xmlns:a16="http://schemas.microsoft.com/office/drawing/2014/main" id="{BFD55BB8-D059-5114-1746-24D99193F54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085828"/>
              </p:ext>
            </p:extLst>
          </p:nvPr>
        </p:nvGraphicFramePr>
        <p:xfrm>
          <a:off x="345546" y="935926"/>
          <a:ext cx="6721940" cy="745783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966821">
                  <a:extLst>
                    <a:ext uri="{9D8B030D-6E8A-4147-A177-3AD203B41FA5}">
                      <a16:colId xmlns:a16="http://schemas.microsoft.com/office/drawing/2014/main" val="648576118"/>
                    </a:ext>
                  </a:extLst>
                </a:gridCol>
                <a:gridCol w="3755119">
                  <a:extLst>
                    <a:ext uri="{9D8B030D-6E8A-4147-A177-3AD203B41FA5}">
                      <a16:colId xmlns:a16="http://schemas.microsoft.com/office/drawing/2014/main" val="1275282691"/>
                    </a:ext>
                  </a:extLst>
                </a:gridCol>
              </a:tblGrid>
              <a:tr h="276289">
                <a:tc>
                  <a:txBody>
                    <a:bodyPr/>
                    <a:lstStyle/>
                    <a:p>
                      <a:r>
                        <a:rPr lang="en-AU" sz="1200" b="1" dirty="0"/>
                        <a:t>Oligo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b="1" dirty="0"/>
                        <a:t>Sequenc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03538268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r>
                        <a:rPr lang="en-AU" sz="1200" dirty="0"/>
                        <a:t>X-B Forwar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CACCGCTTGGTTAGGGTGAGTGC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9555678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/>
                        <a:t>X-B 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AAACAGCACTCACCCTAACCAAG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33900956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r>
                        <a:rPr lang="en-AU" sz="1200" dirty="0"/>
                        <a:t>X-C Forwar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CACCGCTGGGAATTAGAATGCCAG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95066961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/>
                        <a:t>X-C 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AAACTCTGGCATTCTAATTCCCAG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01045816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r>
                        <a:rPr lang="en-AU" sz="1200" dirty="0"/>
                        <a:t>X-D Forwar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CACCGTAAGTGCTGTGTGCTGCTA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83686913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/>
                        <a:t>X-D 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AAACGTAGCAGCACACAGCACTTA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86248326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r>
                        <a:rPr lang="en-AU" sz="1200" dirty="0"/>
                        <a:t>Sequencing oligo 1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b="0" i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ATTTCTTGGGTAGTTTGCAGT</a:t>
                      </a:r>
                      <a:endParaRPr lang="en-AU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04446905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/>
                        <a:t>Sequencing oligo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b="0" i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GTTTCGCCACCTCTGACTTG</a:t>
                      </a:r>
                      <a:endParaRPr lang="en-AU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5373537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/>
                        <a:t>Ccna1-Cas9-EGFP genotyping Forwar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GGCACTCCAGAGTTCTCTG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64978779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/>
                        <a:t>Ccna1-Cas9-EGFP genotyping 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CTTGTACTCGTCGGTGATCA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84559413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/>
                        <a:t>X shredder genotyping common Forwar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ACTGCCAAGTAGGAAAGTCCC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28581874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/>
                        <a:t>X-B genotyping 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AAACAGCACTCACCCTAACCAAG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78184392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/>
                        <a:t>X-C genotyping 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AAACTCTGGCATTCTAATTCCCAG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70722442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/>
                        <a:t>X-D genotyping 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AAACGTAGCAGCACACAGCACTTA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78117688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/>
                        <a:t>X-D single cut site Forwar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GGTTCTCAAGCACCAGCACAGAT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19706929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/>
                        <a:t>X-D single cut site 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AGGAGTTCCAGTTTGTCTGTGG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87119048"/>
                  </a:ext>
                </a:extLst>
              </a:tr>
              <a:tr h="27292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/>
                        <a:t>X-C single cut site Forwar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GAGGTGTGGAGAATTCACTAGAGGTCT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74322161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/>
                        <a:t>X-C single cut site 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GGAAGCAGCGGCAGGATTA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96574989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/>
                        <a:t>X-B Large Deletion Forwar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GAATTGAACCACAACCACGGT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19142821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/>
                        <a:t>X-B Large Deletion 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GGAGAGAAGGTGGAGTGGATAAG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27125651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 err="1"/>
                        <a:t>Rpgr</a:t>
                      </a:r>
                      <a:r>
                        <a:rPr lang="en-AU" sz="1200" dirty="0"/>
                        <a:t> qPCR Forwar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GATGACGATGAAGTGGAGACTGAG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29876296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 err="1"/>
                        <a:t>Rpgr</a:t>
                      </a:r>
                      <a:r>
                        <a:rPr lang="en-AU" sz="1200" dirty="0"/>
                        <a:t> qPCR 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GCCTGTACTACTTGCTCCACTAC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35163346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/>
                        <a:t>TLR7 qPCR Forwar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TGGAGAGCCGGTGATAACAGATA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54386783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/>
                        <a:t>TLR7 qPCR 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TCAGTAACTGGAGTCTGTCCCAA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841236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/>
                        <a:t>DMD qPCR Forwar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CTGTTGGAGGTACCTGCACTGGC 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80049906"/>
                  </a:ext>
                </a:extLst>
              </a:tr>
              <a:tr h="27628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/>
                        <a:t>DMD qPCR 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200" dirty="0"/>
                        <a:t>ACTCGATCAAGCAGAGACAGCCA 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6364081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029315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360</TotalTime>
  <Words>439</Words>
  <Application>Microsoft Macintosh PowerPoint</Application>
  <PresentationFormat>Custom</PresentationFormat>
  <Paragraphs>176</Paragraphs>
  <Slides>7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 Daniel Bunting</dc:creator>
  <cp:lastModifiedBy>Paul Thomas</cp:lastModifiedBy>
  <cp:revision>536</cp:revision>
  <cp:lastPrinted>2023-09-21T06:23:11Z</cp:lastPrinted>
  <dcterms:created xsi:type="dcterms:W3CDTF">2022-01-19T22:53:28Z</dcterms:created>
  <dcterms:modified xsi:type="dcterms:W3CDTF">2023-12-05T10:05:30Z</dcterms:modified>
</cp:coreProperties>
</file>